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  <p:sldId id="257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30"/>
    <p:restoredTop sz="94655"/>
  </p:normalViewPr>
  <p:slideViewPr>
    <p:cSldViewPr snapToGrid="0">
      <p:cViewPr varScale="1">
        <p:scale>
          <a:sx n="94" d="100"/>
          <a:sy n="94" d="100"/>
        </p:scale>
        <p:origin x="116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396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33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408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73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983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474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969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047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550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884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304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D639A4-CC4C-774B-8B9C-AE6083FE8D58}" type="datetimeFigureOut">
              <a:rPr lang="en-US" smtClean="0"/>
              <a:t>5/1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0B2C70-5032-F341-B4BF-742B95EA1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82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14374142-C39A-20C5-0F3A-6EEBF419B8FE}"/>
              </a:ext>
            </a:extLst>
          </p:cNvPr>
          <p:cNvSpPr txBox="1">
            <a:spLocks/>
          </p:cNvSpPr>
          <p:nvPr/>
        </p:nvSpPr>
        <p:spPr>
          <a:xfrm>
            <a:off x="796306" y="2147302"/>
            <a:ext cx="7871444" cy="1939925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2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ZATION OF  BLOOD-BRAIN BARRIER L-ARGININE UPTAKE USING IN SITU BRAIN PERFUSIONS.</a:t>
            </a:r>
            <a:br>
              <a:rPr lang="en-US" sz="2275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2275" dirty="0"/>
          </a:p>
        </p:txBody>
      </p:sp>
      <p:sp>
        <p:nvSpPr>
          <p:cNvPr id="12" name="Subtitle 4">
            <a:extLst>
              <a:ext uri="{FF2B5EF4-FFF2-40B4-BE49-F238E27FC236}">
                <a16:creationId xmlns:a16="http://schemas.microsoft.com/office/drawing/2014/main" id="{9B37BA23-1DC7-429E-8A28-1C412D0D69EF}"/>
              </a:ext>
            </a:extLst>
          </p:cNvPr>
          <p:cNvSpPr txBox="1">
            <a:spLocks/>
          </p:cNvSpPr>
          <p:nvPr/>
        </p:nvSpPr>
        <p:spPr>
          <a:xfrm>
            <a:off x="1017278" y="1886913"/>
            <a:ext cx="7429500" cy="13453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vised SUPPLEMENTARY MATERIAL</a:t>
            </a:r>
          </a:p>
        </p:txBody>
      </p:sp>
      <p:sp>
        <p:nvSpPr>
          <p:cNvPr id="2" name="Subtitle 4">
            <a:extLst>
              <a:ext uri="{FF2B5EF4-FFF2-40B4-BE49-F238E27FC236}">
                <a16:creationId xmlns:a16="http://schemas.microsoft.com/office/drawing/2014/main" id="{91667207-2B28-A4B4-A392-B288B92177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017278" y="3924759"/>
            <a:ext cx="7429500" cy="1345307"/>
          </a:xfrm>
        </p:spPr>
        <p:txBody>
          <a:bodyPr>
            <a:norm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ids and Barriers of CNS</a:t>
            </a:r>
          </a:p>
        </p:txBody>
      </p:sp>
    </p:spTree>
    <p:extLst>
      <p:ext uri="{BB962C8B-B14F-4D97-AF65-F5344CB8AC3E}">
        <p14:creationId xmlns:p14="http://schemas.microsoft.com/office/powerpoint/2010/main" val="2314793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6BB20F0-9FBB-44E8-6B33-727A09B191B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1115CA8-0EC7-A6B3-99A7-1971D03D8097}"/>
              </a:ext>
            </a:extLst>
          </p:cNvPr>
          <p:cNvSpPr txBox="1"/>
          <p:nvPr/>
        </p:nvSpPr>
        <p:spPr>
          <a:xfrm>
            <a:off x="1069288" y="5615858"/>
            <a:ext cx="7490873" cy="7677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1</a:t>
            </a:r>
            <a:r>
              <a:rPr lang="en-US" sz="14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Vascular volume determined by </a:t>
            </a:r>
            <a:r>
              <a:rPr lang="en-US" sz="1463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r>
              <a:rPr lang="en-US" sz="14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Sucrose for experiments with A. altered pH and B. depleted sodium. Data maintain within physiological vascular volume (1.0-1.8 x 10</a:t>
            </a:r>
            <a:r>
              <a:rPr lang="en-US" sz="1463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r>
              <a:rPr lang="en-US" sz="14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L/g). Values are mean </a:t>
            </a:r>
            <a:r>
              <a:rPr lang="en-US" sz="1463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± SEM.</a:t>
            </a:r>
            <a:endParaRPr lang="en-US" sz="146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622AE9A-61AA-AE1F-F876-E0D3C9AFF74D}"/>
              </a:ext>
            </a:extLst>
          </p:cNvPr>
          <p:cNvSpPr txBox="1"/>
          <p:nvPr/>
        </p:nvSpPr>
        <p:spPr>
          <a:xfrm>
            <a:off x="215349" y="858286"/>
            <a:ext cx="2420984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99C247A-79A8-514D-F1A6-2249415511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4550" y="1543050"/>
            <a:ext cx="7454900" cy="3771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01290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E0D9EAB-39FB-E261-5F92-6246F1502DC4}"/>
              </a:ext>
            </a:extLst>
          </p:cNvPr>
          <p:cNvSpPr txBox="1"/>
          <p:nvPr/>
        </p:nvSpPr>
        <p:spPr>
          <a:xfrm>
            <a:off x="1069288" y="5615858"/>
            <a:ext cx="7490873" cy="7677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2</a:t>
            </a:r>
            <a:r>
              <a:rPr lang="en-US" sz="14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Vascular volume for </a:t>
            </a:r>
            <a:r>
              <a:rPr lang="en-US" sz="1463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perfusion</a:t>
            </a:r>
            <a:r>
              <a:rPr lang="en-US" sz="14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eriments with A. amino acid transport inhibitors and B. cationic amino acids determined by </a:t>
            </a:r>
            <a:r>
              <a:rPr lang="en-US" sz="1463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r>
              <a:rPr lang="en-US" sz="14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Sucrose. Data maintain within physiological vascular volume (1.0-1.7 x 10</a:t>
            </a:r>
            <a:r>
              <a:rPr lang="en-US" sz="1463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r>
              <a:rPr lang="en-US" sz="14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L/g). Values are mean </a:t>
            </a:r>
            <a:r>
              <a:rPr lang="en-US" sz="1463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± SEM.</a:t>
            </a:r>
            <a:endParaRPr lang="en-US" sz="146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0CC83CF-7FD1-4352-6EE1-4689BDDC59F8}"/>
              </a:ext>
            </a:extLst>
          </p:cNvPr>
          <p:cNvSpPr txBox="1"/>
          <p:nvPr/>
        </p:nvSpPr>
        <p:spPr>
          <a:xfrm>
            <a:off x="215349" y="858286"/>
            <a:ext cx="2420984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B7AEBE7-D752-F775-3D36-710E5FD05F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3750" y="1295400"/>
            <a:ext cx="7556500" cy="426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6553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</TotalTime>
  <Words>115</Words>
  <Application>Microsoft Macintosh PowerPoint</Application>
  <PresentationFormat>On-screen Show (4:3)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rpenter, Olivia</dc:creator>
  <cp:lastModifiedBy>Carpenter, Olivia</cp:lastModifiedBy>
  <cp:revision>10</cp:revision>
  <dcterms:created xsi:type="dcterms:W3CDTF">2026-03-10T22:08:43Z</dcterms:created>
  <dcterms:modified xsi:type="dcterms:W3CDTF">2026-05-16T02:53:21Z</dcterms:modified>
</cp:coreProperties>
</file>